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2E189-904B-48A6-930C-A218D39145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E839A-1CE7-4627-9026-F6580E2B1C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4295F-F9FA-4D4B-863C-3724F9623D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A8117-9012-431E-99F5-79A78135C2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5CD08-6F99-405D-A16F-B190ABFDA1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ABD37-9848-4FBE-8D8F-75CB807FB1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19EFBF-5FE6-4FF0-89CA-89846B6885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7D9BB-0DC7-4E62-B769-19712A457C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8BB71-F6F7-428A-940D-02897DB51D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BCB0D-AA99-4230-9940-231CB61D1E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279CE-B947-4537-A44D-2F3E202B83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7360A-FE67-4951-9CB9-5F8C59173A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74C4D2-0858-494E-AD58-FE3960BAF3B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80"/>
          <p:cNvSpPr/>
          <p:nvPr/>
        </p:nvSpPr>
        <p:spPr>
          <a:xfrm>
            <a:off x="2785320" y="271440"/>
            <a:ext cx="1694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237645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kyushuense</a:t>
            </a:r>
            <a:r>
              <a:rPr b="0" i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82"/>
          <p:cNvSpPr/>
          <p:nvPr/>
        </p:nvSpPr>
        <p:spPr>
          <a:xfrm>
            <a:off x="2788200" y="436680"/>
            <a:ext cx="168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7651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. proliferatum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84"/>
          <p:cNvSpPr/>
          <p:nvPr/>
        </p:nvSpPr>
        <p:spPr>
          <a:xfrm>
            <a:off x="2784240" y="601560"/>
            <a:ext cx="1125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FRC T-796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. po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386"/>
          <p:cNvSpPr/>
          <p:nvPr/>
        </p:nvSpPr>
        <p:spPr>
          <a:xfrm>
            <a:off x="2786400" y="765000"/>
            <a:ext cx="160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030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oxysp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88"/>
          <p:cNvSpPr/>
          <p:nvPr/>
        </p:nvSpPr>
        <p:spPr>
          <a:xfrm>
            <a:off x="2787480" y="930240"/>
            <a:ext cx="1538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1212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culm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90"/>
          <p:cNvSpPr/>
          <p:nvPr/>
        </p:nvSpPr>
        <p:spPr>
          <a:xfrm>
            <a:off x="2789280" y="1095480"/>
            <a:ext cx="169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008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392"/>
          <p:cNvSpPr/>
          <p:nvPr/>
        </p:nvSpPr>
        <p:spPr>
          <a:xfrm>
            <a:off x="2786040" y="1260360"/>
            <a:ext cx="154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11323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94"/>
          <p:cNvSpPr/>
          <p:nvPr/>
        </p:nvSpPr>
        <p:spPr>
          <a:xfrm>
            <a:off x="2788200" y="1424160"/>
            <a:ext cx="179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바탕"/>
              </a:rPr>
              <a:t>TC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3491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96"/>
          <p:cNvSpPr/>
          <p:nvPr/>
        </p:nvSpPr>
        <p:spPr>
          <a:xfrm>
            <a:off x="2787120" y="1589040"/>
            <a:ext cx="1529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216.7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prolifer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98"/>
          <p:cNvSpPr/>
          <p:nvPr/>
        </p:nvSpPr>
        <p:spPr>
          <a:xfrm>
            <a:off x="2788200" y="1754280"/>
            <a:ext cx="172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027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gramine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400"/>
          <p:cNvSpPr/>
          <p:nvPr/>
        </p:nvSpPr>
        <p:spPr>
          <a:xfrm>
            <a:off x="2786400" y="1919160"/>
            <a:ext cx="148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FRC T-99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402"/>
          <p:cNvSpPr/>
          <p:nvPr/>
        </p:nvSpPr>
        <p:spPr>
          <a:xfrm>
            <a:off x="2788200" y="2082960"/>
            <a:ext cx="186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63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404"/>
          <p:cNvSpPr/>
          <p:nvPr/>
        </p:nvSpPr>
        <p:spPr>
          <a:xfrm>
            <a:off x="2787120" y="2247840"/>
            <a:ext cx="162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ATCC3801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ubglutina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06"/>
          <p:cNvSpPr/>
          <p:nvPr/>
        </p:nvSpPr>
        <p:spPr>
          <a:xfrm>
            <a:off x="2789280" y="2413080"/>
            <a:ext cx="157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576.7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08"/>
          <p:cNvSpPr/>
          <p:nvPr/>
        </p:nvSpPr>
        <p:spPr>
          <a:xfrm>
            <a:off x="2784600" y="2577960"/>
            <a:ext cx="151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NRR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490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kyushu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10"/>
          <p:cNvSpPr/>
          <p:nvPr/>
        </p:nvSpPr>
        <p:spPr>
          <a:xfrm>
            <a:off x="2787120" y="2743200"/>
            <a:ext cx="151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0264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asiatic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12"/>
          <p:cNvSpPr/>
          <p:nvPr/>
        </p:nvSpPr>
        <p:spPr>
          <a:xfrm>
            <a:off x="2787840" y="2906640"/>
            <a:ext cx="1783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11983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14"/>
          <p:cNvSpPr/>
          <p:nvPr/>
        </p:nvSpPr>
        <p:spPr>
          <a:xfrm>
            <a:off x="2786400" y="3071880"/>
            <a:ext cx="155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FRC T-100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16"/>
          <p:cNvSpPr/>
          <p:nvPr/>
        </p:nvSpPr>
        <p:spPr>
          <a:xfrm>
            <a:off x="2786400" y="3236760"/>
            <a:ext cx="1604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40321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oxysp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18"/>
          <p:cNvSpPr/>
          <p:nvPr/>
        </p:nvSpPr>
        <p:spPr>
          <a:xfrm>
            <a:off x="2784960" y="3402000"/>
            <a:ext cx="1263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05947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po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20"/>
          <p:cNvSpPr/>
          <p:nvPr/>
        </p:nvSpPr>
        <p:spPr>
          <a:xfrm>
            <a:off x="2786400" y="3565440"/>
            <a:ext cx="1418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434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. equiset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22"/>
          <p:cNvSpPr/>
          <p:nvPr/>
        </p:nvSpPr>
        <p:spPr>
          <a:xfrm>
            <a:off x="2786760" y="3730680"/>
            <a:ext cx="169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537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ubglutina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24"/>
          <p:cNvSpPr/>
          <p:nvPr/>
        </p:nvSpPr>
        <p:spPr>
          <a:xfrm>
            <a:off x="2786760" y="3895560"/>
            <a:ext cx="141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72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equiset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26"/>
          <p:cNvSpPr/>
          <p:nvPr/>
        </p:nvSpPr>
        <p:spPr>
          <a:xfrm>
            <a:off x="2787480" y="4060800"/>
            <a:ext cx="1608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236521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incar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28"/>
          <p:cNvSpPr/>
          <p:nvPr/>
        </p:nvSpPr>
        <p:spPr>
          <a:xfrm>
            <a:off x="2787840" y="4224240"/>
            <a:ext cx="167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71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acumi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30"/>
          <p:cNvSpPr/>
          <p:nvPr/>
        </p:nvSpPr>
        <p:spPr>
          <a:xfrm>
            <a:off x="2786760" y="4389480"/>
            <a:ext cx="1550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485.9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acumi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32"/>
          <p:cNvSpPr/>
          <p:nvPr/>
        </p:nvSpPr>
        <p:spPr>
          <a:xfrm>
            <a:off x="2789280" y="4554360"/>
            <a:ext cx="161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10031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34"/>
          <p:cNvSpPr/>
          <p:nvPr/>
        </p:nvSpPr>
        <p:spPr>
          <a:xfrm>
            <a:off x="3009600" y="4719600"/>
            <a:ext cx="183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842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decemcellul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36"/>
          <p:cNvSpPr/>
          <p:nvPr/>
        </p:nvSpPr>
        <p:spPr>
          <a:xfrm>
            <a:off x="3009600" y="4883040"/>
            <a:ext cx="183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842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decemcellul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38"/>
          <p:cNvSpPr/>
          <p:nvPr/>
        </p:nvSpPr>
        <p:spPr>
          <a:xfrm>
            <a:off x="3228120" y="5048280"/>
            <a:ext cx="1353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632.7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dime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40"/>
          <p:cNvSpPr/>
          <p:nvPr/>
        </p:nvSpPr>
        <p:spPr>
          <a:xfrm>
            <a:off x="3457800" y="5213520"/>
            <a:ext cx="1474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7465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. dime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42"/>
          <p:cNvSpPr/>
          <p:nvPr/>
        </p:nvSpPr>
        <p:spPr>
          <a:xfrm>
            <a:off x="3902040" y="5378400"/>
            <a:ext cx="1312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853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44"/>
          <p:cNvSpPr/>
          <p:nvPr/>
        </p:nvSpPr>
        <p:spPr>
          <a:xfrm>
            <a:off x="3901680" y="5541840"/>
            <a:ext cx="118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BRC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850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46"/>
          <p:cNvSpPr/>
          <p:nvPr/>
        </p:nvSpPr>
        <p:spPr>
          <a:xfrm>
            <a:off x="4581720" y="5707080"/>
            <a:ext cx="1312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903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52"/>
          <p:cNvSpPr/>
          <p:nvPr/>
        </p:nvSpPr>
        <p:spPr>
          <a:xfrm>
            <a:off x="4224240" y="5872320"/>
            <a:ext cx="1986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68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crodochium niv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54"/>
          <p:cNvSpPr/>
          <p:nvPr/>
        </p:nvSpPr>
        <p:spPr>
          <a:xfrm>
            <a:off x="4172760" y="6037200"/>
            <a:ext cx="2052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6205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　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crodochium niv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57"/>
          <p:cNvSpPr/>
          <p:nvPr/>
        </p:nvSpPr>
        <p:spPr>
          <a:xfrm>
            <a:off x="3229920" y="6200640"/>
            <a:ext cx="157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634.7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merism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59"/>
          <p:cNvSpPr/>
          <p:nvPr/>
        </p:nvSpPr>
        <p:spPr>
          <a:xfrm>
            <a:off x="3229920" y="6365880"/>
            <a:ext cx="1699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650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merism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61"/>
          <p:cNvSpPr/>
          <p:nvPr/>
        </p:nvSpPr>
        <p:spPr>
          <a:xfrm>
            <a:off x="3227400" y="6531120"/>
            <a:ext cx="1355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169.3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rv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63"/>
          <p:cNvSpPr/>
          <p:nvPr/>
        </p:nvSpPr>
        <p:spPr>
          <a:xfrm>
            <a:off x="3444840" y="6696000"/>
            <a:ext cx="1355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638.7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rv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67"/>
          <p:cNvSpPr/>
          <p:nvPr/>
        </p:nvSpPr>
        <p:spPr>
          <a:xfrm>
            <a:off x="3458160" y="6859440"/>
            <a:ext cx="155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R74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Neurospora cras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73"/>
          <p:cNvSpPr/>
          <p:nvPr/>
        </p:nvSpPr>
        <p:spPr>
          <a:xfrm>
            <a:off x="2099520" y="7024680"/>
            <a:ext cx="149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840045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. lateriti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75"/>
          <p:cNvSpPr/>
          <p:nvPr/>
        </p:nvSpPr>
        <p:spPr>
          <a:xfrm>
            <a:off x="2097360" y="7189920"/>
            <a:ext cx="140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CBS393.9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tricinc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77"/>
          <p:cNvSpPr/>
          <p:nvPr/>
        </p:nvSpPr>
        <p:spPr>
          <a:xfrm>
            <a:off x="2097720" y="7354800"/>
            <a:ext cx="163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ATCC20025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avenace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79"/>
          <p:cNvSpPr/>
          <p:nvPr/>
        </p:nvSpPr>
        <p:spPr>
          <a:xfrm>
            <a:off x="2100600" y="7520040"/>
            <a:ext cx="1810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ATCC3818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ibberella tricinc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81"/>
          <p:cNvSpPr/>
          <p:nvPr/>
        </p:nvSpPr>
        <p:spPr>
          <a:xfrm>
            <a:off x="2099520" y="7683480"/>
            <a:ext cx="149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534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lateriti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83"/>
          <p:cNvSpPr/>
          <p:nvPr/>
        </p:nvSpPr>
        <p:spPr>
          <a:xfrm>
            <a:off x="2098440" y="7848720"/>
            <a:ext cx="152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555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tricinc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485"/>
          <p:cNvSpPr/>
          <p:nvPr/>
        </p:nvSpPr>
        <p:spPr>
          <a:xfrm>
            <a:off x="2097720" y="8013600"/>
            <a:ext cx="163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FF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3920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. avenace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489"/>
          <p:cNvSpPr/>
          <p:nvPr/>
        </p:nvSpPr>
        <p:spPr>
          <a:xfrm>
            <a:off x="2532960" y="8178840"/>
            <a:ext cx="2506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isconsin 54-1255 </a:t>
            </a:r>
            <a:r>
              <a:rPr b="0" i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Penicillium chrysogen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91"/>
          <p:cNvSpPr/>
          <p:nvPr/>
        </p:nvSpPr>
        <p:spPr>
          <a:xfrm>
            <a:off x="3270600" y="8342280"/>
            <a:ext cx="145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RIB4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Aspergillus oryz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グループ化 53"/>
          <p:cNvGrpSpPr/>
          <p:nvPr/>
        </p:nvGrpSpPr>
        <p:grpSpPr>
          <a:xfrm>
            <a:off x="1413000" y="347760"/>
            <a:ext cx="3152520" cy="8070840"/>
            <a:chOff x="1413000" y="347760"/>
            <a:chExt cx="3152520" cy="8070840"/>
          </a:xfrm>
        </p:grpSpPr>
        <p:sp>
          <p:nvSpPr>
            <p:cNvPr id="92" name="Freeform 458"/>
            <p:cNvSpPr/>
            <p:nvPr/>
          </p:nvSpPr>
          <p:spPr>
            <a:xfrm>
              <a:off x="3211560" y="6278760"/>
              <a:ext cx="1440" cy="155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5520"/>
                <a:gd name="textAreaBottom" fmla="*/ 155880 h 155520"/>
              </a:gdLst>
              <a:ahLst/>
              <a:rect l="textAreaLeft" t="textAreaTop" r="textAreaRight" b="textAreaBottom"/>
              <a:pathLst>
                <a:path w="1588" h="98">
                  <a:moveTo>
                    <a:pt x="0" y="98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460"/>
            <p:cNvSpPr/>
            <p:nvPr/>
          </p:nvSpPr>
          <p:spPr>
            <a:xfrm>
              <a:off x="3211560" y="6442200"/>
              <a:ext cx="1440" cy="74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588" h="47">
                  <a:moveTo>
                    <a:pt x="0" y="47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462"/>
            <p:cNvSpPr/>
            <p:nvPr/>
          </p:nvSpPr>
          <p:spPr>
            <a:xfrm>
              <a:off x="3211560" y="6532920"/>
              <a:ext cx="1440" cy="74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588" h="47">
                  <a:moveTo>
                    <a:pt x="0" y="0"/>
                  </a:moveTo>
                  <a:lnTo>
                    <a:pt x="0" y="4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474"/>
            <p:cNvSpPr/>
            <p:nvPr/>
          </p:nvSpPr>
          <p:spPr>
            <a:xfrm>
              <a:off x="2082600" y="7101000"/>
              <a:ext cx="1440" cy="404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404640"/>
                <a:gd name="textAreaBottom" fmla="*/ 405000 h 404640"/>
              </a:gdLst>
              <a:ahLst/>
              <a:rect l="textAreaLeft" t="textAreaTop" r="textAreaRight" b="textAreaBottom"/>
              <a:pathLst>
                <a:path w="1588" h="255">
                  <a:moveTo>
                    <a:pt x="0" y="255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476"/>
            <p:cNvSpPr/>
            <p:nvPr/>
          </p:nvSpPr>
          <p:spPr>
            <a:xfrm>
              <a:off x="2082600" y="7266240"/>
              <a:ext cx="1440" cy="320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320400"/>
                <a:gd name="textAreaBottom" fmla="*/ 320760 h 320400"/>
              </a:gdLst>
              <a:ahLst/>
              <a:rect l="textAreaLeft" t="textAreaTop" r="textAreaRight" b="textAreaBottom"/>
              <a:pathLst>
                <a:path w="1588" h="202">
                  <a:moveTo>
                    <a:pt x="0" y="202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478"/>
            <p:cNvSpPr/>
            <p:nvPr/>
          </p:nvSpPr>
          <p:spPr>
            <a:xfrm>
              <a:off x="2082600" y="7431480"/>
              <a:ext cx="1440" cy="74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588" h="47">
                  <a:moveTo>
                    <a:pt x="0" y="47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480"/>
            <p:cNvSpPr/>
            <p:nvPr/>
          </p:nvSpPr>
          <p:spPr>
            <a:xfrm>
              <a:off x="2082600" y="7521840"/>
              <a:ext cx="1440" cy="74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588" h="47">
                  <a:moveTo>
                    <a:pt x="0" y="0"/>
                  </a:moveTo>
                  <a:lnTo>
                    <a:pt x="0" y="4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482"/>
            <p:cNvSpPr/>
            <p:nvPr/>
          </p:nvSpPr>
          <p:spPr>
            <a:xfrm>
              <a:off x="2082600" y="7604280"/>
              <a:ext cx="1440" cy="155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5520"/>
                <a:gd name="textAreaBottom" fmla="*/ 155880 h 155520"/>
              </a:gdLst>
              <a:ahLst/>
              <a:rect l="textAreaLeft" t="textAreaTop" r="textAreaRight" b="textAreaBottom"/>
              <a:pathLst>
                <a:path w="1588" h="98">
                  <a:moveTo>
                    <a:pt x="0" y="0"/>
                  </a:moveTo>
                  <a:lnTo>
                    <a:pt x="0" y="98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484"/>
            <p:cNvSpPr/>
            <p:nvPr/>
          </p:nvSpPr>
          <p:spPr>
            <a:xfrm>
              <a:off x="2082600" y="7687080"/>
              <a:ext cx="1440" cy="2379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237960"/>
                <a:gd name="textAreaBottom" fmla="*/ 238320 h 237960"/>
              </a:gdLst>
              <a:ahLst/>
              <a:rect l="textAreaLeft" t="textAreaTop" r="textAreaRight" b="textAreaBottom"/>
              <a:pathLst>
                <a:path w="1588" h="150">
                  <a:moveTo>
                    <a:pt x="0" y="0"/>
                  </a:moveTo>
                  <a:lnTo>
                    <a:pt x="0" y="1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486"/>
            <p:cNvSpPr/>
            <p:nvPr/>
          </p:nvSpPr>
          <p:spPr>
            <a:xfrm>
              <a:off x="2082600" y="7604280"/>
              <a:ext cx="1440" cy="485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485640"/>
                <a:gd name="textAreaBottom" fmla="*/ 486000 h 485640"/>
              </a:gdLst>
              <a:ahLst/>
              <a:rect l="textAreaLeft" t="textAreaTop" r="textAreaRight" b="textAreaBottom"/>
              <a:pathLst>
                <a:path w="1588" h="306">
                  <a:moveTo>
                    <a:pt x="0" y="0"/>
                  </a:moveTo>
                  <a:lnTo>
                    <a:pt x="0" y="30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" name="グループ化 74"/>
            <p:cNvGrpSpPr/>
            <p:nvPr/>
          </p:nvGrpSpPr>
          <p:grpSpPr>
            <a:xfrm>
              <a:off x="1413000" y="347760"/>
              <a:ext cx="3152520" cy="8070840"/>
              <a:chOff x="1413000" y="347760"/>
              <a:chExt cx="3152520" cy="8070840"/>
            </a:xfrm>
          </p:grpSpPr>
          <p:sp>
            <p:nvSpPr>
              <p:cNvPr id="103" name="Freeform 381"/>
              <p:cNvSpPr/>
              <p:nvPr/>
            </p:nvSpPr>
            <p:spPr>
              <a:xfrm>
                <a:off x="2771640" y="3477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383"/>
              <p:cNvSpPr/>
              <p:nvPr/>
            </p:nvSpPr>
            <p:spPr>
              <a:xfrm>
                <a:off x="2771640" y="4381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385"/>
              <p:cNvSpPr/>
              <p:nvPr/>
            </p:nvSpPr>
            <p:spPr>
              <a:xfrm>
                <a:off x="2771640" y="677880"/>
                <a:ext cx="1440" cy="122688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226880"/>
                  <a:gd name="textAreaBottom" fmla="*/ 1227240 h 1226880"/>
                </a:gdLst>
                <a:ahLst/>
                <a:rect l="textAreaLeft" t="textAreaTop" r="textAreaRight" b="textAreaBottom"/>
                <a:pathLst>
                  <a:path w="1588" h="773">
                    <a:moveTo>
                      <a:pt x="0" y="77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387"/>
              <p:cNvSpPr/>
              <p:nvPr/>
            </p:nvSpPr>
            <p:spPr>
              <a:xfrm>
                <a:off x="2771640" y="842760"/>
                <a:ext cx="1440" cy="8143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814320"/>
                  <a:gd name="textAreaBottom" fmla="*/ 814680 h 814320"/>
                </a:gdLst>
                <a:ahLst/>
                <a:rect l="textAreaLeft" t="textAreaTop" r="textAreaRight" b="textAreaBottom"/>
                <a:pathLst>
                  <a:path w="1588" h="513">
                    <a:moveTo>
                      <a:pt x="0" y="51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389"/>
              <p:cNvSpPr/>
              <p:nvPr/>
            </p:nvSpPr>
            <p:spPr>
              <a:xfrm>
                <a:off x="2771640" y="10065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391"/>
              <p:cNvSpPr/>
              <p:nvPr/>
            </p:nvSpPr>
            <p:spPr>
              <a:xfrm>
                <a:off x="2771640" y="10969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393"/>
              <p:cNvSpPr/>
              <p:nvPr/>
            </p:nvSpPr>
            <p:spPr>
              <a:xfrm>
                <a:off x="2771640" y="13366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8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395"/>
              <p:cNvSpPr/>
              <p:nvPr/>
            </p:nvSpPr>
            <p:spPr>
              <a:xfrm>
                <a:off x="2771640" y="142704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397"/>
              <p:cNvSpPr/>
              <p:nvPr/>
            </p:nvSpPr>
            <p:spPr>
              <a:xfrm>
                <a:off x="2771640" y="1509840"/>
                <a:ext cx="1440" cy="155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1588" h="98">
                    <a:moveTo>
                      <a:pt x="0" y="0"/>
                    </a:moveTo>
                    <a:lnTo>
                      <a:pt x="0" y="9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399"/>
              <p:cNvSpPr/>
              <p:nvPr/>
            </p:nvSpPr>
            <p:spPr>
              <a:xfrm>
                <a:off x="2771640" y="183024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401"/>
              <p:cNvSpPr/>
              <p:nvPr/>
            </p:nvSpPr>
            <p:spPr>
              <a:xfrm>
                <a:off x="2771640" y="19209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403"/>
              <p:cNvSpPr/>
              <p:nvPr/>
            </p:nvSpPr>
            <p:spPr>
              <a:xfrm>
                <a:off x="2771640" y="1755720"/>
                <a:ext cx="1440" cy="4046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404640"/>
                  <a:gd name="textAreaBottom" fmla="*/ 405000 h 404640"/>
                </a:gdLst>
                <a:ahLst/>
                <a:rect l="textAreaLeft" t="textAreaTop" r="textAreaRight" b="textAreaBottom"/>
                <a:pathLst>
                  <a:path w="1588" h="255">
                    <a:moveTo>
                      <a:pt x="0" y="0"/>
                    </a:moveTo>
                    <a:lnTo>
                      <a:pt x="0" y="25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405"/>
              <p:cNvSpPr/>
              <p:nvPr/>
            </p:nvSpPr>
            <p:spPr>
              <a:xfrm>
                <a:off x="2771640" y="1838160"/>
                <a:ext cx="1440" cy="4856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485640"/>
                  <a:gd name="textAreaBottom" fmla="*/ 486000 h 485640"/>
                </a:gdLst>
                <a:ahLst/>
                <a:rect l="textAreaLeft" t="textAreaTop" r="textAreaRight" b="textAreaBottom"/>
                <a:pathLst>
                  <a:path w="1588" h="306">
                    <a:moveTo>
                      <a:pt x="0" y="0"/>
                    </a:moveTo>
                    <a:lnTo>
                      <a:pt x="0" y="30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407"/>
              <p:cNvSpPr/>
              <p:nvPr/>
            </p:nvSpPr>
            <p:spPr>
              <a:xfrm>
                <a:off x="2771640" y="1755720"/>
                <a:ext cx="1440" cy="7333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33320"/>
                  <a:gd name="textAreaBottom" fmla="*/ 733680 h 733320"/>
                </a:gdLst>
                <a:ahLst/>
                <a:rect l="textAreaLeft" t="textAreaTop" r="textAreaRight" b="textAreaBottom"/>
                <a:pathLst>
                  <a:path w="1588" h="462">
                    <a:moveTo>
                      <a:pt x="0" y="0"/>
                    </a:moveTo>
                    <a:lnTo>
                      <a:pt x="0" y="462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409"/>
              <p:cNvSpPr/>
              <p:nvPr/>
            </p:nvSpPr>
            <p:spPr>
              <a:xfrm>
                <a:off x="2771640" y="1755720"/>
                <a:ext cx="1440" cy="8985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898560"/>
                  <a:gd name="textAreaBottom" fmla="*/ 898920 h 898560"/>
                </a:gdLst>
                <a:ahLst/>
                <a:rect l="textAreaLeft" t="textAreaTop" r="textAreaRight" b="textAreaBottom"/>
                <a:pathLst>
                  <a:path w="1588" h="566">
                    <a:moveTo>
                      <a:pt x="0" y="0"/>
                    </a:moveTo>
                    <a:lnTo>
                      <a:pt x="0" y="56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411"/>
              <p:cNvSpPr/>
              <p:nvPr/>
            </p:nvSpPr>
            <p:spPr>
              <a:xfrm>
                <a:off x="2771640" y="1838160"/>
                <a:ext cx="1440" cy="9810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81000"/>
                  <a:gd name="textAreaBottom" fmla="*/ 981360 h 981000"/>
                </a:gdLst>
                <a:ahLst/>
                <a:rect l="textAreaLeft" t="textAreaTop" r="textAreaRight" b="textAreaBottom"/>
                <a:pathLst>
                  <a:path w="1588" h="618">
                    <a:moveTo>
                      <a:pt x="0" y="0"/>
                    </a:moveTo>
                    <a:lnTo>
                      <a:pt x="0" y="61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413"/>
              <p:cNvSpPr/>
              <p:nvPr/>
            </p:nvSpPr>
            <p:spPr>
              <a:xfrm>
                <a:off x="2771640" y="1920960"/>
                <a:ext cx="1440" cy="10620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062000"/>
                  <a:gd name="textAreaBottom" fmla="*/ 1062360 h 1062000"/>
                </a:gdLst>
                <a:ahLst/>
                <a:rect l="textAreaLeft" t="textAreaTop" r="textAreaRight" b="textAreaBottom"/>
                <a:pathLst>
                  <a:path w="1588" h="669">
                    <a:moveTo>
                      <a:pt x="0" y="0"/>
                    </a:moveTo>
                    <a:lnTo>
                      <a:pt x="0" y="66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415"/>
              <p:cNvSpPr/>
              <p:nvPr/>
            </p:nvSpPr>
            <p:spPr>
              <a:xfrm>
                <a:off x="2771640" y="2003400"/>
                <a:ext cx="1440" cy="11444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144440"/>
                  <a:gd name="textAreaBottom" fmla="*/ 1144800 h 1144440"/>
                </a:gdLst>
                <a:ahLst/>
                <a:rect l="textAreaLeft" t="textAreaTop" r="textAreaRight" b="textAreaBottom"/>
                <a:pathLst>
                  <a:path w="1588" h="721">
                    <a:moveTo>
                      <a:pt x="0" y="0"/>
                    </a:moveTo>
                    <a:lnTo>
                      <a:pt x="0" y="72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417"/>
              <p:cNvSpPr/>
              <p:nvPr/>
            </p:nvSpPr>
            <p:spPr>
              <a:xfrm>
                <a:off x="2771640" y="2003400"/>
                <a:ext cx="1440" cy="130968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309680"/>
                  <a:gd name="textAreaBottom" fmla="*/ 1310040 h 1309680"/>
                </a:gdLst>
                <a:ahLst/>
                <a:rect l="textAreaLeft" t="textAreaTop" r="textAreaRight" b="textAreaBottom"/>
                <a:pathLst>
                  <a:path w="1588" h="825">
                    <a:moveTo>
                      <a:pt x="0" y="0"/>
                    </a:moveTo>
                    <a:lnTo>
                      <a:pt x="0" y="82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419"/>
              <p:cNvSpPr/>
              <p:nvPr/>
            </p:nvSpPr>
            <p:spPr>
              <a:xfrm>
                <a:off x="2771640" y="347832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8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Freeform 421"/>
              <p:cNvSpPr/>
              <p:nvPr/>
            </p:nvSpPr>
            <p:spPr>
              <a:xfrm>
                <a:off x="2771640" y="35686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8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423"/>
              <p:cNvSpPr/>
              <p:nvPr/>
            </p:nvSpPr>
            <p:spPr>
              <a:xfrm>
                <a:off x="2771640" y="38070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425"/>
              <p:cNvSpPr/>
              <p:nvPr/>
            </p:nvSpPr>
            <p:spPr>
              <a:xfrm>
                <a:off x="2771640" y="38973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Freeform 427"/>
              <p:cNvSpPr/>
              <p:nvPr/>
            </p:nvSpPr>
            <p:spPr>
              <a:xfrm>
                <a:off x="2771640" y="3979800"/>
                <a:ext cx="1440" cy="15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1588" h="99">
                    <a:moveTo>
                      <a:pt x="0" y="0"/>
                    </a:moveTo>
                    <a:lnTo>
                      <a:pt x="0" y="9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Freeform 429"/>
              <p:cNvSpPr/>
              <p:nvPr/>
            </p:nvSpPr>
            <p:spPr>
              <a:xfrm>
                <a:off x="2771640" y="4300560"/>
                <a:ext cx="1440" cy="15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1588" h="99">
                    <a:moveTo>
                      <a:pt x="0" y="9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431"/>
              <p:cNvSpPr/>
              <p:nvPr/>
            </p:nvSpPr>
            <p:spPr>
              <a:xfrm>
                <a:off x="2771640" y="44658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433"/>
              <p:cNvSpPr/>
              <p:nvPr/>
            </p:nvSpPr>
            <p:spPr>
              <a:xfrm>
                <a:off x="2771640" y="45561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8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435"/>
              <p:cNvSpPr/>
              <p:nvPr/>
            </p:nvSpPr>
            <p:spPr>
              <a:xfrm>
                <a:off x="2990880" y="479592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8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437"/>
              <p:cNvSpPr/>
              <p:nvPr/>
            </p:nvSpPr>
            <p:spPr>
              <a:xfrm>
                <a:off x="2990880" y="48862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8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2" name="グループ化 104"/>
              <p:cNvGrpSpPr/>
              <p:nvPr/>
            </p:nvGrpSpPr>
            <p:grpSpPr>
              <a:xfrm>
                <a:off x="1413000" y="347760"/>
                <a:ext cx="3152520" cy="8070840"/>
                <a:chOff x="1413000" y="347760"/>
                <a:chExt cx="3152520" cy="8070840"/>
              </a:xfrm>
            </p:grpSpPr>
            <p:sp>
              <p:nvSpPr>
                <p:cNvPr id="133" name="Freeform 443"/>
                <p:cNvSpPr/>
                <p:nvPr/>
              </p:nvSpPr>
              <p:spPr>
                <a:xfrm>
                  <a:off x="3887640" y="5454720"/>
                  <a:ext cx="1440" cy="7272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72720"/>
                    <a:gd name="textAreaBottom" fmla="*/ 72720 h 72720"/>
                  </a:gdLst>
                  <a:ahLst/>
                  <a:rect l="textAreaLeft" t="textAreaTop" r="textAreaRight" b="textAreaBottom"/>
                  <a:pathLst>
                    <a:path w="1588" h="46">
                      <a:moveTo>
                        <a:pt x="0" y="46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920" bIns="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445"/>
                <p:cNvSpPr/>
                <p:nvPr/>
              </p:nvSpPr>
              <p:spPr>
                <a:xfrm>
                  <a:off x="3887640" y="5545440"/>
                  <a:ext cx="1440" cy="7452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74520"/>
                    <a:gd name="textAreaBottom" fmla="*/ 74880 h 74520"/>
                  </a:gdLst>
                  <a:ahLst/>
                  <a:rect l="textAreaLeft" t="textAreaTop" r="textAreaRight" b="textAreaBottom"/>
                  <a:pathLst>
                    <a:path w="1588" h="47">
                      <a:moveTo>
                        <a:pt x="0" y="0"/>
                      </a:moveTo>
                      <a:lnTo>
                        <a:pt x="0" y="4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080" bIns="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5" name="グループ化 107"/>
                <p:cNvGrpSpPr/>
                <p:nvPr/>
              </p:nvGrpSpPr>
              <p:grpSpPr>
                <a:xfrm>
                  <a:off x="1413000" y="347760"/>
                  <a:ext cx="3152520" cy="8070840"/>
                  <a:chOff x="1413000" y="347760"/>
                  <a:chExt cx="3152520" cy="8070840"/>
                </a:xfrm>
              </p:grpSpPr>
              <p:sp>
                <p:nvSpPr>
                  <p:cNvPr id="136" name="Line 471"/>
                  <p:cNvSpPr/>
                  <p:nvPr/>
                </p:nvSpPr>
                <p:spPr>
                  <a:xfrm>
                    <a:off x="2771640" y="347760"/>
                    <a:ext cx="1440" cy="2751120"/>
                  </a:xfrm>
                  <a:prstGeom prst="line">
                    <a:avLst/>
                  </a:prstGeom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37" name="グループ化 109"/>
                  <p:cNvGrpSpPr/>
                  <p:nvPr/>
                </p:nvGrpSpPr>
                <p:grpSpPr>
                  <a:xfrm>
                    <a:off x="1413000" y="3106800"/>
                    <a:ext cx="3152520" cy="5311800"/>
                    <a:chOff x="1413000" y="3106800"/>
                    <a:chExt cx="3152520" cy="5311800"/>
                  </a:xfrm>
                </p:grpSpPr>
                <p:sp>
                  <p:nvSpPr>
                    <p:cNvPr id="138" name="Freeform 439"/>
                    <p:cNvSpPr/>
                    <p:nvPr/>
                  </p:nvSpPr>
                  <p:spPr>
                    <a:xfrm>
                      <a:off x="3211560" y="5124600"/>
                      <a:ext cx="1440" cy="156960"/>
                    </a:xfrm>
                    <a:custGeom>
                      <a:avLst/>
                      <a:gdLst>
                        <a:gd name="textAreaLeft" fmla="*/ 0 w 1440"/>
                        <a:gd name="textAreaRight" fmla="*/ 1800 w 1440"/>
                        <a:gd name="textAreaTop" fmla="*/ 0 h 156960"/>
                        <a:gd name="textAreaBottom" fmla="*/ 157320 h 156960"/>
                      </a:gdLst>
                      <a:ahLst/>
                      <a:rect l="textAreaLeft" t="textAreaTop" r="textAreaRight" b="textAreaBottom"/>
                      <a:pathLst>
                        <a:path w="1588" h="99">
                          <a:moveTo>
                            <a:pt x="0" y="99"/>
                          </a:move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9" name="Freeform 441"/>
                    <p:cNvSpPr/>
                    <p:nvPr/>
                  </p:nvSpPr>
                  <p:spPr>
                    <a:xfrm>
                      <a:off x="3440160" y="5289480"/>
                      <a:ext cx="1440" cy="156960"/>
                    </a:xfrm>
                    <a:custGeom>
                      <a:avLst/>
                      <a:gdLst>
                        <a:gd name="textAreaLeft" fmla="*/ 0 w 1440"/>
                        <a:gd name="textAreaRight" fmla="*/ 1800 w 1440"/>
                        <a:gd name="textAreaTop" fmla="*/ 0 h 156960"/>
                        <a:gd name="textAreaBottom" fmla="*/ 157320 h 156960"/>
                      </a:gdLst>
                      <a:ahLst/>
                      <a:rect l="textAreaLeft" t="textAreaTop" r="textAreaRight" b="textAreaBottom"/>
                      <a:pathLst>
                        <a:path w="1588" h="99">
                          <a:moveTo>
                            <a:pt x="0" y="99"/>
                          </a:move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0" name="Freeform 447"/>
                    <p:cNvSpPr/>
                    <p:nvPr/>
                  </p:nvSpPr>
                  <p:spPr>
                    <a:xfrm>
                      <a:off x="3887640" y="5627880"/>
                      <a:ext cx="677880" cy="155520"/>
                    </a:xfrm>
                    <a:custGeom>
                      <a:avLst/>
                      <a:gdLst>
                        <a:gd name="textAreaLeft" fmla="*/ 0 w 677880"/>
                        <a:gd name="textAreaRight" fmla="*/ 677880 w 677880"/>
                        <a:gd name="textAreaTop" fmla="*/ 0 h 155520"/>
                        <a:gd name="textAreaBottom" fmla="*/ 155880 h 155520"/>
                      </a:gdLst>
                      <a:ahLst/>
                      <a:rect l="textAreaLeft" t="textAreaTop" r="textAreaRight" b="textAreaBottom"/>
                      <a:pathLst>
                        <a:path w="427" h="98">
                          <a:moveTo>
                            <a:pt x="0" y="0"/>
                          </a:moveTo>
                          <a:lnTo>
                            <a:pt x="0" y="98"/>
                          </a:lnTo>
                          <a:lnTo>
                            <a:pt x="427" y="98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1" name="Line 448"/>
                    <p:cNvSpPr/>
                    <p:nvPr/>
                  </p:nvSpPr>
                  <p:spPr>
                    <a:xfrm>
                      <a:off x="3887640" y="5454720"/>
                      <a:ext cx="1440" cy="155520"/>
                    </a:xfrm>
                    <a:prstGeom prst="line">
                      <a:avLst/>
                    </a:prstGeom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2" name="Freeform 449"/>
                    <p:cNvSpPr/>
                    <p:nvPr/>
                  </p:nvSpPr>
                  <p:spPr>
                    <a:xfrm>
                      <a:off x="3440160" y="5462640"/>
                      <a:ext cx="447480" cy="156960"/>
                    </a:xfrm>
                    <a:custGeom>
                      <a:avLst/>
                      <a:gdLst>
                        <a:gd name="textAreaLeft" fmla="*/ 0 w 447480"/>
                        <a:gd name="textAreaRight" fmla="*/ 447840 w 447480"/>
                        <a:gd name="textAreaTop" fmla="*/ 0 h 156960"/>
                        <a:gd name="textAreaBottom" fmla="*/ 157320 h 156960"/>
                      </a:gdLst>
                      <a:ahLst/>
                      <a:rect l="textAreaLeft" t="textAreaTop" r="textAreaRight" b="textAreaBottom"/>
                      <a:pathLst>
                        <a:path w="282" h="99">
                          <a:moveTo>
                            <a:pt x="0" y="0"/>
                          </a:moveTo>
                          <a:lnTo>
                            <a:pt x="0" y="99"/>
                          </a:lnTo>
                          <a:lnTo>
                            <a:pt x="282" y="99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3" name="Freeform 450"/>
                    <p:cNvSpPr/>
                    <p:nvPr/>
                  </p:nvSpPr>
                  <p:spPr>
                    <a:xfrm>
                      <a:off x="3211560" y="5297400"/>
                      <a:ext cx="228600" cy="156960"/>
                    </a:xfrm>
                    <a:custGeom>
                      <a:avLst/>
                      <a:gdLst>
                        <a:gd name="textAreaLeft" fmla="*/ 0 w 228600"/>
                        <a:gd name="textAreaRight" fmla="*/ 228960 w 228600"/>
                        <a:gd name="textAreaTop" fmla="*/ 0 h 156960"/>
                        <a:gd name="textAreaBottom" fmla="*/ 157320 h 156960"/>
                      </a:gdLst>
                      <a:ahLst/>
                      <a:rect l="textAreaLeft" t="textAreaTop" r="textAreaRight" b="textAreaBottom"/>
                      <a:pathLst>
                        <a:path w="144" h="99">
                          <a:moveTo>
                            <a:pt x="0" y="0"/>
                          </a:moveTo>
                          <a:lnTo>
                            <a:pt x="0" y="99"/>
                          </a:lnTo>
                          <a:lnTo>
                            <a:pt x="144" y="99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4" name="Freeform 451"/>
                    <p:cNvSpPr/>
                    <p:nvPr/>
                  </p:nvSpPr>
                  <p:spPr>
                    <a:xfrm>
                      <a:off x="2990880" y="5289480"/>
                      <a:ext cx="220320" cy="361800"/>
                    </a:xfrm>
                    <a:custGeom>
                      <a:avLst/>
                      <a:gdLst>
                        <a:gd name="textAreaLeft" fmla="*/ 0 w 220320"/>
                        <a:gd name="textAreaRight" fmla="*/ 220680 w 220320"/>
                        <a:gd name="textAreaTop" fmla="*/ 0 h 361800"/>
                        <a:gd name="textAreaBottom" fmla="*/ 362160 h 361800"/>
                      </a:gdLst>
                      <a:ahLst/>
                      <a:rect l="textAreaLeft" t="textAreaTop" r="textAreaRight" b="textAreaBottom"/>
                      <a:pathLst>
                        <a:path w="139" h="228">
                          <a:moveTo>
                            <a:pt x="0" y="228"/>
                          </a:moveTo>
                          <a:lnTo>
                            <a:pt x="0" y="0"/>
                          </a:lnTo>
                          <a:lnTo>
                            <a:pt x="139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5" name="Freeform 453"/>
                    <p:cNvSpPr/>
                    <p:nvPr/>
                  </p:nvSpPr>
                  <p:spPr>
                    <a:xfrm>
                      <a:off x="4205160" y="5948280"/>
                      <a:ext cx="1440" cy="74520"/>
                    </a:xfrm>
                    <a:custGeom>
                      <a:avLst/>
                      <a:gdLst>
                        <a:gd name="textAreaLeft" fmla="*/ 0 w 1440"/>
                        <a:gd name="textAreaRight" fmla="*/ 1800 w 1440"/>
                        <a:gd name="textAreaTop" fmla="*/ 0 h 74520"/>
                        <a:gd name="textAreaBottom" fmla="*/ 74880 h 74520"/>
                      </a:gdLst>
                      <a:ahLst/>
                      <a:rect l="textAreaLeft" t="textAreaTop" r="textAreaRight" b="textAreaBottom"/>
                      <a:pathLst>
                        <a:path w="1588" h="47">
                          <a:moveTo>
                            <a:pt x="0" y="47"/>
                          </a:move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8080" bIns="280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6" name="Freeform 455"/>
                    <p:cNvSpPr/>
                    <p:nvPr/>
                  </p:nvSpPr>
                  <p:spPr>
                    <a:xfrm>
                      <a:off x="4205160" y="6039000"/>
                      <a:ext cx="1440" cy="74520"/>
                    </a:xfrm>
                    <a:custGeom>
                      <a:avLst/>
                      <a:gdLst>
                        <a:gd name="textAreaLeft" fmla="*/ 0 w 1440"/>
                        <a:gd name="textAreaRight" fmla="*/ 1800 w 1440"/>
                        <a:gd name="textAreaTop" fmla="*/ 0 h 74520"/>
                        <a:gd name="textAreaBottom" fmla="*/ 74880 h 74520"/>
                      </a:gdLst>
                      <a:ahLst/>
                      <a:rect l="textAreaLeft" t="textAreaTop" r="textAreaRight" b="textAreaBottom"/>
                      <a:pathLst>
                        <a:path w="1588" h="47">
                          <a:moveTo>
                            <a:pt x="0" y="0"/>
                          </a:moveTo>
                          <a:lnTo>
                            <a:pt x="0" y="47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8080" bIns="280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7" name="Freeform 456"/>
                    <p:cNvSpPr/>
                    <p:nvPr/>
                  </p:nvSpPr>
                  <p:spPr>
                    <a:xfrm>
                      <a:off x="2990880" y="5668920"/>
                      <a:ext cx="1214280" cy="361800"/>
                    </a:xfrm>
                    <a:custGeom>
                      <a:avLst/>
                      <a:gdLst>
                        <a:gd name="textAreaLeft" fmla="*/ 0 w 1214280"/>
                        <a:gd name="textAreaRight" fmla="*/ 1214640 w 1214280"/>
                        <a:gd name="textAreaTop" fmla="*/ 0 h 361800"/>
                        <a:gd name="textAreaBottom" fmla="*/ 362160 h 361800"/>
                      </a:gdLst>
                      <a:ahLst/>
                      <a:rect l="textAreaLeft" t="textAreaTop" r="textAreaRight" b="textAreaBottom"/>
                      <a:pathLst>
                        <a:path w="765" h="228">
                          <a:moveTo>
                            <a:pt x="0" y="0"/>
                          </a:moveTo>
                          <a:lnTo>
                            <a:pt x="0" y="228"/>
                          </a:lnTo>
                          <a:lnTo>
                            <a:pt x="765" y="228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8" name="Freeform 464"/>
                    <p:cNvSpPr/>
                    <p:nvPr/>
                  </p:nvSpPr>
                  <p:spPr>
                    <a:xfrm>
                      <a:off x="3211560" y="6532560"/>
                      <a:ext cx="218880" cy="239400"/>
                    </a:xfrm>
                    <a:custGeom>
                      <a:avLst/>
                      <a:gdLst>
                        <a:gd name="textAreaLeft" fmla="*/ 0 w 218880"/>
                        <a:gd name="textAreaRight" fmla="*/ 219240 w 218880"/>
                        <a:gd name="textAreaTop" fmla="*/ 0 h 239400"/>
                        <a:gd name="textAreaBottom" fmla="*/ 239760 h 239400"/>
                      </a:gdLst>
                      <a:ahLst/>
                      <a:rect l="textAreaLeft" t="textAreaTop" r="textAreaRight" b="textAreaBottom"/>
                      <a:pathLst>
                        <a:path w="138" h="151">
                          <a:moveTo>
                            <a:pt x="0" y="0"/>
                          </a:moveTo>
                          <a:lnTo>
                            <a:pt x="0" y="151"/>
                          </a:lnTo>
                          <a:lnTo>
                            <a:pt x="138" y="151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9" name="Line 465"/>
                    <p:cNvSpPr/>
                    <p:nvPr/>
                  </p:nvSpPr>
                  <p:spPr>
                    <a:xfrm>
                      <a:off x="3211560" y="6278760"/>
                      <a:ext cx="1440" cy="237960"/>
                    </a:xfrm>
                    <a:prstGeom prst="line">
                      <a:avLst/>
                    </a:prstGeom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0" name="Freeform 466"/>
                    <p:cNvSpPr/>
                    <p:nvPr/>
                  </p:nvSpPr>
                  <p:spPr>
                    <a:xfrm>
                      <a:off x="2990880" y="5915160"/>
                      <a:ext cx="220320" cy="609480"/>
                    </a:xfrm>
                    <a:custGeom>
                      <a:avLst/>
                      <a:gdLst>
                        <a:gd name="textAreaLeft" fmla="*/ 0 w 220320"/>
                        <a:gd name="textAreaRight" fmla="*/ 220680 w 220320"/>
                        <a:gd name="textAreaTop" fmla="*/ 0 h 609480"/>
                        <a:gd name="textAreaBottom" fmla="*/ 609840 h 609480"/>
                      </a:gdLst>
                      <a:ahLst/>
                      <a:rect l="textAreaLeft" t="textAreaTop" r="textAreaRight" b="textAreaBottom"/>
                      <a:pathLst>
                        <a:path w="139" h="384">
                          <a:moveTo>
                            <a:pt x="0" y="0"/>
                          </a:moveTo>
                          <a:lnTo>
                            <a:pt x="0" y="384"/>
                          </a:lnTo>
                          <a:lnTo>
                            <a:pt x="139" y="384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1" name="Freeform 468"/>
                    <p:cNvSpPr/>
                    <p:nvPr/>
                  </p:nvSpPr>
                  <p:spPr>
                    <a:xfrm>
                      <a:off x="2990880" y="5873760"/>
                      <a:ext cx="453960" cy="1063440"/>
                    </a:xfrm>
                    <a:custGeom>
                      <a:avLst/>
                      <a:gdLst>
                        <a:gd name="textAreaLeft" fmla="*/ 0 w 453960"/>
                        <a:gd name="textAreaRight" fmla="*/ 454320 w 453960"/>
                        <a:gd name="textAreaTop" fmla="*/ 0 h 1063440"/>
                        <a:gd name="textAreaBottom" fmla="*/ 1063800 h 1063440"/>
                      </a:gdLst>
                      <a:ahLst/>
                      <a:rect l="textAreaLeft" t="textAreaTop" r="textAreaRight" b="textAreaBottom"/>
                      <a:pathLst>
                        <a:path w="286" h="670">
                          <a:moveTo>
                            <a:pt x="0" y="0"/>
                          </a:moveTo>
                          <a:lnTo>
                            <a:pt x="0" y="670"/>
                          </a:lnTo>
                          <a:lnTo>
                            <a:pt x="286" y="67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2" name="Line 469"/>
                    <p:cNvSpPr/>
                    <p:nvPr/>
                  </p:nvSpPr>
                  <p:spPr>
                    <a:xfrm>
                      <a:off x="2990880" y="4795920"/>
                      <a:ext cx="1440" cy="1062000"/>
                    </a:xfrm>
                    <a:prstGeom prst="line">
                      <a:avLst/>
                    </a:prstGeom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Freeform 470"/>
                    <p:cNvSpPr/>
                    <p:nvPr/>
                  </p:nvSpPr>
                  <p:spPr>
                    <a:xfrm>
                      <a:off x="2771640" y="3114720"/>
                      <a:ext cx="218880" cy="2751120"/>
                    </a:xfrm>
                    <a:custGeom>
                      <a:avLst/>
                      <a:gdLst>
                        <a:gd name="textAreaLeft" fmla="*/ 0 w 218880"/>
                        <a:gd name="textAreaRight" fmla="*/ 219240 w 218880"/>
                        <a:gd name="textAreaTop" fmla="*/ 0 h 2751120"/>
                        <a:gd name="textAreaBottom" fmla="*/ 2751120 h 2751120"/>
                      </a:gdLst>
                      <a:ahLst/>
                      <a:rect l="textAreaLeft" t="textAreaTop" r="textAreaRight" b="textAreaBottom"/>
                      <a:pathLst>
                        <a:path w="138" h="1733">
                          <a:moveTo>
                            <a:pt x="0" y="0"/>
                          </a:moveTo>
                          <a:lnTo>
                            <a:pt x="0" y="1733"/>
                          </a:lnTo>
                          <a:lnTo>
                            <a:pt x="138" y="1733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Freeform 472"/>
                    <p:cNvSpPr/>
                    <p:nvPr/>
                  </p:nvSpPr>
                  <p:spPr>
                    <a:xfrm>
                      <a:off x="2082600" y="3106800"/>
                      <a:ext cx="688680" cy="2482920"/>
                    </a:xfrm>
                    <a:custGeom>
                      <a:avLst/>
                      <a:gdLst>
                        <a:gd name="textAreaLeft" fmla="*/ 0 w 688680"/>
                        <a:gd name="textAreaRight" fmla="*/ 689040 w 688680"/>
                        <a:gd name="textAreaTop" fmla="*/ 0 h 2482920"/>
                        <a:gd name="textAreaBottom" fmla="*/ 2483280 h 2482920"/>
                      </a:gdLst>
                      <a:ahLst/>
                      <a:rect l="textAreaLeft" t="textAreaTop" r="textAreaRight" b="textAreaBottom"/>
                      <a:pathLst>
                        <a:path w="434" h="1564">
                          <a:moveTo>
                            <a:pt x="0" y="1564"/>
                          </a:moveTo>
                          <a:lnTo>
                            <a:pt x="0" y="0"/>
                          </a:lnTo>
                          <a:lnTo>
                            <a:pt x="434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Line 487"/>
                    <p:cNvSpPr/>
                    <p:nvPr/>
                  </p:nvSpPr>
                  <p:spPr>
                    <a:xfrm>
                      <a:off x="2082600" y="5607000"/>
                      <a:ext cx="1440" cy="2482920"/>
                    </a:xfrm>
                    <a:prstGeom prst="line">
                      <a:avLst/>
                    </a:prstGeom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Freeform 488"/>
                    <p:cNvSpPr/>
                    <p:nvPr/>
                  </p:nvSpPr>
                  <p:spPr>
                    <a:xfrm>
                      <a:off x="1413000" y="5599080"/>
                      <a:ext cx="669600" cy="1360440"/>
                    </a:xfrm>
                    <a:custGeom>
                      <a:avLst/>
                      <a:gdLst>
                        <a:gd name="textAreaLeft" fmla="*/ 0 w 669600"/>
                        <a:gd name="textAreaRight" fmla="*/ 669600 w 669600"/>
                        <a:gd name="textAreaTop" fmla="*/ 0 h 1360440"/>
                        <a:gd name="textAreaBottom" fmla="*/ 1360800 h 1360440"/>
                      </a:gdLst>
                      <a:ahLst/>
                      <a:rect l="textAreaLeft" t="textAreaTop" r="textAreaRight" b="textAreaBottom"/>
                      <a:pathLst>
                        <a:path w="422" h="857">
                          <a:moveTo>
                            <a:pt x="0" y="857"/>
                          </a:moveTo>
                          <a:lnTo>
                            <a:pt x="0" y="0"/>
                          </a:lnTo>
                          <a:lnTo>
                            <a:pt x="422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7" name="Freeform 490"/>
                    <p:cNvSpPr/>
                    <p:nvPr/>
                  </p:nvSpPr>
                  <p:spPr>
                    <a:xfrm>
                      <a:off x="2290680" y="8255160"/>
                      <a:ext cx="220320" cy="72720"/>
                    </a:xfrm>
                    <a:custGeom>
                      <a:avLst/>
                      <a:gdLst>
                        <a:gd name="textAreaLeft" fmla="*/ 0 w 220320"/>
                        <a:gd name="textAreaRight" fmla="*/ 220680 w 220320"/>
                        <a:gd name="textAreaTop" fmla="*/ 0 h 72720"/>
                        <a:gd name="textAreaBottom" fmla="*/ 72720 h 72720"/>
                      </a:gdLst>
                      <a:ahLst/>
                      <a:rect l="textAreaLeft" t="textAreaTop" r="textAreaRight" b="textAreaBottom"/>
                      <a:pathLst>
                        <a:path w="139" h="46">
                          <a:moveTo>
                            <a:pt x="0" y="46"/>
                          </a:moveTo>
                          <a:lnTo>
                            <a:pt x="0" y="0"/>
                          </a:lnTo>
                          <a:lnTo>
                            <a:pt x="139" y="0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5920" bIns="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8" name="Freeform 492"/>
                    <p:cNvSpPr/>
                    <p:nvPr/>
                  </p:nvSpPr>
                  <p:spPr>
                    <a:xfrm>
                      <a:off x="2290680" y="8345880"/>
                      <a:ext cx="965160" cy="72720"/>
                    </a:xfrm>
                    <a:custGeom>
                      <a:avLst/>
                      <a:gdLst>
                        <a:gd name="textAreaLeft" fmla="*/ 0 w 965160"/>
                        <a:gd name="textAreaRight" fmla="*/ 965520 w 965160"/>
                        <a:gd name="textAreaTop" fmla="*/ 0 h 72720"/>
                        <a:gd name="textAreaBottom" fmla="*/ 72720 h 72720"/>
                      </a:gdLst>
                      <a:ahLst/>
                      <a:rect l="textAreaLeft" t="textAreaTop" r="textAreaRight" b="textAreaBottom"/>
                      <a:pathLst>
                        <a:path w="608" h="46">
                          <a:moveTo>
                            <a:pt x="0" y="0"/>
                          </a:moveTo>
                          <a:lnTo>
                            <a:pt x="0" y="46"/>
                          </a:lnTo>
                          <a:lnTo>
                            <a:pt x="608" y="46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5920" bIns="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9" name="Freeform 493"/>
                    <p:cNvSpPr/>
                    <p:nvPr/>
                  </p:nvSpPr>
                  <p:spPr>
                    <a:xfrm>
                      <a:off x="1413000" y="6975720"/>
                      <a:ext cx="877680" cy="1361880"/>
                    </a:xfrm>
                    <a:custGeom>
                      <a:avLst/>
                      <a:gdLst>
                        <a:gd name="textAreaLeft" fmla="*/ 0 w 877680"/>
                        <a:gd name="textAreaRight" fmla="*/ 878040 w 877680"/>
                        <a:gd name="textAreaTop" fmla="*/ 0 h 1361880"/>
                        <a:gd name="textAreaBottom" fmla="*/ 1362240 h 1361880"/>
                      </a:gdLst>
                      <a:ahLst/>
                      <a:rect l="textAreaLeft" t="textAreaTop" r="textAreaRight" b="textAreaBottom"/>
                      <a:pathLst>
                        <a:path w="553" h="858">
                          <a:moveTo>
                            <a:pt x="0" y="0"/>
                          </a:moveTo>
                          <a:lnTo>
                            <a:pt x="0" y="858"/>
                          </a:lnTo>
                          <a:lnTo>
                            <a:pt x="553" y="858"/>
                          </a:lnTo>
                        </a:path>
                      </a:pathLst>
                    </a:custGeom>
                    <a:noFill/>
                    <a:ln cap="sq"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</p:grpSp>
      <p:sp>
        <p:nvSpPr>
          <p:cNvPr id="160" name="Rectangle 494"/>
          <p:cNvSpPr/>
          <p:nvPr/>
        </p:nvSpPr>
        <p:spPr>
          <a:xfrm>
            <a:off x="4065840" y="60660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  <a:ea typeface="Arial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495"/>
          <p:cNvSpPr/>
          <p:nvPr/>
        </p:nvSpPr>
        <p:spPr>
          <a:xfrm>
            <a:off x="3748320" y="56530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  <a:ea typeface="Arial"/>
              </a:rPr>
              <a:t>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496"/>
          <p:cNvSpPr/>
          <p:nvPr/>
        </p:nvSpPr>
        <p:spPr>
          <a:xfrm>
            <a:off x="2151360" y="8370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  <a:ea typeface="Arial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497"/>
          <p:cNvSpPr/>
          <p:nvPr/>
        </p:nvSpPr>
        <p:spPr>
          <a:xfrm>
            <a:off x="2621160" y="2971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  <a:ea typeface="Arial"/>
              </a:rPr>
              <a:t>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4" name="グループ化 58"/>
          <p:cNvGrpSpPr/>
          <p:nvPr/>
        </p:nvGrpSpPr>
        <p:grpSpPr>
          <a:xfrm>
            <a:off x="1413000" y="8567640"/>
            <a:ext cx="495000" cy="181080"/>
            <a:chOff x="1413000" y="8567640"/>
            <a:chExt cx="495000" cy="181080"/>
          </a:xfrm>
        </p:grpSpPr>
        <p:sp>
          <p:nvSpPr>
            <p:cNvPr id="165" name="Line 498"/>
            <p:cNvSpPr/>
            <p:nvPr/>
          </p:nvSpPr>
          <p:spPr>
            <a:xfrm>
              <a:off x="1413000" y="8600760"/>
              <a:ext cx="4935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499"/>
            <p:cNvSpPr/>
            <p:nvPr/>
          </p:nvSpPr>
          <p:spPr>
            <a:xfrm>
              <a:off x="1413000" y="8567640"/>
              <a:ext cx="1440" cy="66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500"/>
            <p:cNvSpPr/>
            <p:nvPr/>
          </p:nvSpPr>
          <p:spPr>
            <a:xfrm>
              <a:off x="1906560" y="8567640"/>
              <a:ext cx="1440" cy="66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501"/>
            <p:cNvSpPr/>
            <p:nvPr/>
          </p:nvSpPr>
          <p:spPr>
            <a:xfrm>
              <a:off x="1574640" y="864180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0T23:32:51Z</dcterms:created>
  <dc:creator>koba</dc:creator>
  <dc:description/>
  <dc:language>en-US</dc:language>
  <cp:lastModifiedBy>gilb01</cp:lastModifiedBy>
  <dcterms:modified xsi:type="dcterms:W3CDTF">2011-10-14T15:09:11Z</dcterms:modified>
  <cp:revision>2</cp:revision>
  <dc:subject/>
  <dc:title>スライド 1</dc:title>
</cp:coreProperties>
</file>